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56" r:id="rId2"/>
  </p:sldIdLst>
  <p:sldSz cx="9144000" cy="6858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25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9FD5656C-3030-4DA6-9861-1E756EC56CA2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9D8F6B52-B39C-49CE-8059-19DC33F0463F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A97AD-E410-4C3A-96CE-0E9B36A1EEEA}" type="datetimeFigureOut">
              <a:rPr lang="de-AT" smtClean="0"/>
              <a:pPr/>
              <a:t>01.02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45609-CBD9-4327-B0FB-75B31BB9D70C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1989236" y="1340768"/>
            <a:ext cx="2654772" cy="24040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No formal exclusion criteria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4869557" y="1744241"/>
            <a:ext cx="2664296" cy="64807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Excluded  (n=6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Not meeting inclusion criteria (n=0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Declined to participate (n= 1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Treated in clinical trial applying conc. CTX (n=5)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1962150" y="5773613"/>
            <a:ext cx="4482058" cy="86717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Number of patients analyzed for:</a:t>
            </a:r>
            <a:b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</a:b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Baseline characteristics (n=155); pts. excluded (n=0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AZA dose, application, regimen and dose changes (n=155); pts. excluded (n=0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Toxicity and AE (n=155); 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pts. excluded (n=0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36000" marR="0" lvl="0" indent="0" algn="just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Overall survival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rgbClr val="403838"/>
                </a:solidFill>
                <a:effectLst/>
                <a:latin typeface="Arial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(n=155);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pts. excluded (n=0)</a:t>
            </a:r>
            <a:endParaRPr kumimoji="0" lang="en-US" sz="800" b="0" i="0" u="none" strike="noStrike" cap="none" normalizeH="0" baseline="0" smtClean="0">
              <a:ln>
                <a:noFill/>
              </a:ln>
              <a:solidFill>
                <a:srgbClr val="403838"/>
              </a:solidFill>
              <a:effectLst/>
              <a:latin typeface="Arial" pitchFamily="34" charset="0"/>
            </a:endParaRP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Response</a:t>
            </a:r>
            <a:r>
              <a:rPr lang="en-CA" sz="800" smtClean="0">
                <a:latin typeface="Arial" pitchFamily="34" charset="0"/>
              </a:rPr>
              <a:t> (n=155); pts. excluded (n=0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1031" name="AutoShape 7"/>
          <p:cNvCxnSpPr>
            <a:cxnSpLocks noChangeShapeType="1"/>
          </p:cNvCxnSpPr>
          <p:nvPr/>
        </p:nvCxnSpPr>
        <p:spPr bwMode="auto">
          <a:xfrm rot="16200000" flipH="1">
            <a:off x="3051036" y="1272979"/>
            <a:ext cx="157031" cy="457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sp>
        <p:nvSpPr>
          <p:cNvPr id="1033" name="AutoShape 9"/>
          <p:cNvSpPr>
            <a:spLocks noChangeArrowheads="1"/>
          </p:cNvSpPr>
          <p:nvPr/>
        </p:nvSpPr>
        <p:spPr bwMode="auto">
          <a:xfrm>
            <a:off x="176213" y="692696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AT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Inclusion criteria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4" name="AutoShape 10"/>
          <p:cNvSpPr>
            <a:spLocks noChangeArrowheads="1"/>
          </p:cNvSpPr>
          <p:nvPr/>
        </p:nvSpPr>
        <p:spPr bwMode="auto">
          <a:xfrm>
            <a:off x="185738" y="1350293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AT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Exclusion criteria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5" name="Rectangle 11"/>
          <p:cNvSpPr>
            <a:spLocks noChangeArrowheads="1"/>
          </p:cNvSpPr>
          <p:nvPr/>
        </p:nvSpPr>
        <p:spPr bwMode="auto">
          <a:xfrm>
            <a:off x="1979712" y="692696"/>
            <a:ext cx="2664296" cy="504056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Diagnosis of WHO-defined AML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At least one dose of azacitidine applied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Written IC for all pts. alive at the time of inclusion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6" name="Rectangle 12"/>
          <p:cNvSpPr>
            <a:spLocks noChangeArrowheads="1"/>
          </p:cNvSpPr>
          <p:nvPr/>
        </p:nvSpPr>
        <p:spPr bwMode="auto">
          <a:xfrm>
            <a:off x="1979712" y="1744241"/>
            <a:ext cx="2664296" cy="47508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Included (n=155)</a:t>
            </a: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Assessed for eligibility prior to 20.01.12 (n=161)</a:t>
            </a: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Eligible (n=155)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7" name="Rectangle 13"/>
          <p:cNvSpPr>
            <a:spLocks noChangeArrowheads="1"/>
          </p:cNvSpPr>
          <p:nvPr/>
        </p:nvSpPr>
        <p:spPr bwMode="auto">
          <a:xfrm>
            <a:off x="1989237" y="2377455"/>
            <a:ext cx="2654771" cy="144016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Reason for trt. termination (n=134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Death due to any reason (n=33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Disease progression without prior response (n=25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AML-relapse after initial response (n=18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</a:endParaRP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No response (n=18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</a:endParaRP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Toxicity (n=9)</a:t>
            </a:r>
            <a:endParaRPr kumimoji="0" lang="en-CA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</a:endParaRP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Patient’s wish (n=8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Recuurent infectious complications (n=5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Allogeneic SCT (n=4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Other reasons (n=13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No data (n=1)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8" name="Rectangle 14"/>
          <p:cNvSpPr>
            <a:spLocks noChangeArrowheads="1"/>
          </p:cNvSpPr>
          <p:nvPr/>
        </p:nvSpPr>
        <p:spPr bwMode="auto">
          <a:xfrm>
            <a:off x="1989237" y="3976489"/>
            <a:ext cx="2654771" cy="97420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Patient status at cut-off date (21.01.12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Alive and on trt. with AZA (n=21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Alive and no longer on AZA (n=18)</a:t>
            </a: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</a:rPr>
              <a:t>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Lost to follow-up and no longer on AZA (n=1)</a:t>
            </a: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      - allogeneic SCT (n = 1)</a:t>
            </a:r>
          </a:p>
          <a:p>
            <a:pPr marL="3600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      - Unknown reasons (n = 1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de-AT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Dead (n = 114)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41" name="Rectangle 17"/>
          <p:cNvSpPr>
            <a:spLocks noChangeArrowheads="1"/>
          </p:cNvSpPr>
          <p:nvPr/>
        </p:nvSpPr>
        <p:spPr bwMode="auto">
          <a:xfrm>
            <a:off x="1971675" y="5104606"/>
            <a:ext cx="4472533" cy="518542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91440" rIns="91440" bIns="91440" numCol="1" anchor="t" anchorCtr="0" compatLnSpc="1">
            <a:prstTxWarp prst="textNoShape">
              <a:avLst/>
            </a:prstTxWarp>
          </a:bodyPr>
          <a:lstStyle/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Follow-up after trt. discontinuation with AZA: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Performed approximately every 3 months until death (n=154)</a:t>
            </a:r>
          </a:p>
          <a:p>
            <a:pPr marL="36000" marR="0" lvl="1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Symbol" pitchFamily="18" charset="2"/>
              </a:rPr>
              <a:t>¨</a:t>
            </a:r>
            <a:r>
              <a:rPr kumimoji="0" 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  </a:t>
            </a:r>
            <a:r>
              <a:rPr kumimoji="0" lang="en-CA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rPr>
              <a:t>Pts. with loss to follow-up were censored with the date of last follow-up performed (n=1)</a:t>
            </a:r>
            <a:endParaRPr kumimoji="0" lang="de-DE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cxnSp>
        <p:nvCxnSpPr>
          <p:cNvPr id="51" name="AutoShape 7"/>
          <p:cNvCxnSpPr>
            <a:cxnSpLocks noChangeShapeType="1"/>
          </p:cNvCxnSpPr>
          <p:nvPr/>
        </p:nvCxnSpPr>
        <p:spPr bwMode="auto">
          <a:xfrm rot="16200000" flipH="1">
            <a:off x="3051036" y="1653912"/>
            <a:ext cx="157031" cy="457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52" name="AutoShape 7"/>
          <p:cNvCxnSpPr>
            <a:cxnSpLocks noChangeShapeType="1"/>
          </p:cNvCxnSpPr>
          <p:nvPr/>
        </p:nvCxnSpPr>
        <p:spPr bwMode="auto">
          <a:xfrm rot="16200000" flipH="1">
            <a:off x="3051036" y="2292459"/>
            <a:ext cx="157031" cy="457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53" name="AutoShape 7"/>
          <p:cNvCxnSpPr>
            <a:cxnSpLocks noChangeShapeType="1"/>
          </p:cNvCxnSpPr>
          <p:nvPr/>
        </p:nvCxnSpPr>
        <p:spPr bwMode="auto">
          <a:xfrm rot="16200000" flipH="1">
            <a:off x="3055613" y="3895685"/>
            <a:ext cx="157031" cy="457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54" name="AutoShape 7"/>
          <p:cNvCxnSpPr>
            <a:cxnSpLocks noChangeShapeType="1"/>
          </p:cNvCxnSpPr>
          <p:nvPr/>
        </p:nvCxnSpPr>
        <p:spPr bwMode="auto">
          <a:xfrm rot="16200000" flipH="1">
            <a:off x="3055613" y="5028763"/>
            <a:ext cx="157031" cy="457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55" name="AutoShape 7"/>
          <p:cNvCxnSpPr>
            <a:cxnSpLocks noChangeShapeType="1"/>
          </p:cNvCxnSpPr>
          <p:nvPr/>
        </p:nvCxnSpPr>
        <p:spPr bwMode="auto">
          <a:xfrm rot="16200000" flipH="1">
            <a:off x="3055613" y="5699376"/>
            <a:ext cx="157031" cy="4577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cxnSp>
        <p:nvCxnSpPr>
          <p:cNvPr id="56" name="AutoShape 7"/>
          <p:cNvCxnSpPr>
            <a:cxnSpLocks noChangeShapeType="1"/>
          </p:cNvCxnSpPr>
          <p:nvPr/>
        </p:nvCxnSpPr>
        <p:spPr bwMode="auto">
          <a:xfrm>
            <a:off x="4649341" y="1987252"/>
            <a:ext cx="216024" cy="1588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triangle" w="med" len="med"/>
          </a:ln>
          <a:effectLst/>
        </p:spPr>
      </p:cxnSp>
      <p:sp>
        <p:nvSpPr>
          <p:cNvPr id="61" name="AutoShape 10"/>
          <p:cNvSpPr>
            <a:spLocks noChangeArrowheads="1"/>
          </p:cNvSpPr>
          <p:nvPr/>
        </p:nvSpPr>
        <p:spPr bwMode="auto">
          <a:xfrm>
            <a:off x="179512" y="1791866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AT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Enrollment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62" name="AutoShape 10"/>
          <p:cNvSpPr>
            <a:spLocks noChangeArrowheads="1"/>
          </p:cNvSpPr>
          <p:nvPr/>
        </p:nvSpPr>
        <p:spPr bwMode="auto">
          <a:xfrm>
            <a:off x="179512" y="2382788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AT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Discontinued</a:t>
            </a:r>
            <a:r>
              <a:rPr kumimoji="0" lang="de-AT" sz="900" b="1" i="0" u="none" strike="noStrike" cap="none" normalizeH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 trt.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63" name="AutoShape 10"/>
          <p:cNvSpPr>
            <a:spLocks noChangeArrowheads="1"/>
          </p:cNvSpPr>
          <p:nvPr/>
        </p:nvSpPr>
        <p:spPr bwMode="auto">
          <a:xfrm>
            <a:off x="179512" y="3980681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de-AT" sz="9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ndara" pitchFamily="34" charset="0"/>
              </a:rPr>
              <a:t>Patient status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64" name="AutoShape 10"/>
          <p:cNvSpPr>
            <a:spLocks noChangeArrowheads="1"/>
          </p:cNvSpPr>
          <p:nvPr/>
        </p:nvSpPr>
        <p:spPr bwMode="auto">
          <a:xfrm>
            <a:off x="179512" y="5109567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lang="de-AT" sz="900" b="1" smtClean="0">
                <a:latin typeface="Candara" pitchFamily="34" charset="0"/>
              </a:rPr>
              <a:t>Follow-up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65" name="AutoShape 10"/>
          <p:cNvSpPr>
            <a:spLocks noChangeArrowheads="1"/>
          </p:cNvSpPr>
          <p:nvPr/>
        </p:nvSpPr>
        <p:spPr bwMode="auto">
          <a:xfrm>
            <a:off x="179512" y="5767164"/>
            <a:ext cx="1335815" cy="216024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marL="36000" marR="0" lvl="0" indent="0" algn="ctr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lang="de-AT" sz="900" b="1" smtClean="0">
                <a:latin typeface="Candara" pitchFamily="34" charset="0"/>
              </a:rPr>
              <a:t>Analyses</a:t>
            </a:r>
            <a:endParaRPr kumimoji="0" lang="de-DE" sz="9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126554" y="324639"/>
            <a:ext cx="3797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AT" sz="1200" b="1" smtClean="0">
                <a:latin typeface="Arial" pitchFamily="34" charset="0"/>
                <a:cs typeface="Arial" pitchFamily="34" charset="0"/>
              </a:rPr>
              <a:t>Supplemental Figure 1A. Consort Diagram A</a:t>
            </a:r>
            <a:endParaRPr lang="de-AT" sz="1200" b="1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8</Words>
  <Application>Microsoft Office PowerPoint</Application>
  <PresentationFormat>Bildschirmpräsentation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Company>Salzburger Landesklinike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Pleyer Lisa</dc:creator>
  <cp:lastModifiedBy>Pleyer Lisa</cp:lastModifiedBy>
  <cp:revision>12</cp:revision>
  <dcterms:created xsi:type="dcterms:W3CDTF">2012-11-04T16:35:04Z</dcterms:created>
  <dcterms:modified xsi:type="dcterms:W3CDTF">2013-02-01T08:10:17Z</dcterms:modified>
</cp:coreProperties>
</file>